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4DCC08-C849-0F45-BB13-2D3A43B0E648}" v="1" dt="2023-06-29T05:13:01.7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2"/>
    <p:restoredTop sz="94694"/>
  </p:normalViewPr>
  <p:slideViewPr>
    <p:cSldViewPr snapToGrid="0">
      <p:cViewPr>
        <p:scale>
          <a:sx n="100" d="100"/>
          <a:sy n="100" d="100"/>
        </p:scale>
        <p:origin x="2672" y="-2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藤井 匡" userId="d0175c71-90dd-4236-b482-6b7f6a599ccb" providerId="ADAL" clId="{384DCC08-C849-0F45-BB13-2D3A43B0E648}"/>
    <pc:docChg chg="custSel delSld modSld">
      <pc:chgData name="藤井 匡" userId="d0175c71-90dd-4236-b482-6b7f6a599ccb" providerId="ADAL" clId="{384DCC08-C849-0F45-BB13-2D3A43B0E648}" dt="2023-06-29T23:09:26.627" v="43" actId="20577"/>
      <pc:docMkLst>
        <pc:docMk/>
      </pc:docMkLst>
      <pc:sldChg chg="addSp delSp modSp mod">
        <pc:chgData name="藤井 匡" userId="d0175c71-90dd-4236-b482-6b7f6a599ccb" providerId="ADAL" clId="{384DCC08-C849-0F45-BB13-2D3A43B0E648}" dt="2023-06-29T23:09:26.627" v="43" actId="20577"/>
        <pc:sldMkLst>
          <pc:docMk/>
          <pc:sldMk cId="752693718" sldId="256"/>
        </pc:sldMkLst>
        <pc:spChg chg="del">
          <ac:chgData name="藤井 匡" userId="d0175c71-90dd-4236-b482-6b7f6a599ccb" providerId="ADAL" clId="{384DCC08-C849-0F45-BB13-2D3A43B0E648}" dt="2023-06-29T05:14:18.295" v="12" actId="478"/>
          <ac:spMkLst>
            <pc:docMk/>
            <pc:sldMk cId="752693718" sldId="256"/>
            <ac:spMk id="2" creationId="{4AF061D8-38E8-B871-F8EF-C0F4F0327E49}"/>
          </ac:spMkLst>
        </pc:spChg>
        <pc:spChg chg="add mod">
          <ac:chgData name="藤井 匡" userId="d0175c71-90dd-4236-b482-6b7f6a599ccb" providerId="ADAL" clId="{384DCC08-C849-0F45-BB13-2D3A43B0E648}" dt="2023-06-29T23:09:26.627" v="43" actId="20577"/>
          <ac:spMkLst>
            <pc:docMk/>
            <pc:sldMk cId="752693718" sldId="256"/>
            <ac:spMk id="3" creationId="{210E4F6F-6947-6067-7217-472CB8642067}"/>
          </ac:spMkLst>
        </pc:spChg>
      </pc:sldChg>
      <pc:sldChg chg="del">
        <pc:chgData name="藤井 匡" userId="d0175c71-90dd-4236-b482-6b7f6a599ccb" providerId="ADAL" clId="{384DCC08-C849-0F45-BB13-2D3A43B0E648}" dt="2023-06-29T05:12:57.779" v="0" actId="2696"/>
        <pc:sldMkLst>
          <pc:docMk/>
          <pc:sldMk cId="1660982188" sldId="257"/>
        </pc:sldMkLst>
      </pc:sldChg>
    </pc:docChg>
  </pc:docChgLst>
  <pc:docChgLst>
    <pc:chgData name="藤井 匡" userId="d0175c71-90dd-4236-b482-6b7f6a599ccb" providerId="ADAL" clId="{31A66B9B-A4BA-A846-B6C8-9E5957F70A19}"/>
    <pc:docChg chg="custSel modSld">
      <pc:chgData name="藤井 匡" userId="d0175c71-90dd-4236-b482-6b7f6a599ccb" providerId="ADAL" clId="{31A66B9B-A4BA-A846-B6C8-9E5957F70A19}" dt="2023-06-05T06:44:03.928" v="28" actId="20577"/>
      <pc:docMkLst>
        <pc:docMk/>
      </pc:docMkLst>
      <pc:sldChg chg="addSp delSp modSp mod">
        <pc:chgData name="藤井 匡" userId="d0175c71-90dd-4236-b482-6b7f6a599ccb" providerId="ADAL" clId="{31A66B9B-A4BA-A846-B6C8-9E5957F70A19}" dt="2023-06-05T06:43:56.487" v="25" actId="478"/>
        <pc:sldMkLst>
          <pc:docMk/>
          <pc:sldMk cId="752693718" sldId="256"/>
        </pc:sldMkLst>
        <pc:spChg chg="add mod">
          <ac:chgData name="藤井 匡" userId="d0175c71-90dd-4236-b482-6b7f6a599ccb" providerId="ADAL" clId="{31A66B9B-A4BA-A846-B6C8-9E5957F70A19}" dt="2023-06-05T06:43:50.318" v="23" actId="20577"/>
          <ac:spMkLst>
            <pc:docMk/>
            <pc:sldMk cId="752693718" sldId="256"/>
            <ac:spMk id="2" creationId="{4AF061D8-38E8-B871-F8EF-C0F4F0327E49}"/>
          </ac:spMkLst>
        </pc:spChg>
        <pc:spChg chg="add del mod">
          <ac:chgData name="藤井 匡" userId="d0175c71-90dd-4236-b482-6b7f6a599ccb" providerId="ADAL" clId="{31A66B9B-A4BA-A846-B6C8-9E5957F70A19}" dt="2023-06-05T06:43:56.487" v="25" actId="478"/>
          <ac:spMkLst>
            <pc:docMk/>
            <pc:sldMk cId="752693718" sldId="256"/>
            <ac:spMk id="3" creationId="{F9FFA3BD-B2F2-C1AB-191C-6516ABEFDF44}"/>
          </ac:spMkLst>
        </pc:spChg>
        <pc:spChg chg="del mod">
          <ac:chgData name="藤井 匡" userId="d0175c71-90dd-4236-b482-6b7f6a599ccb" providerId="ADAL" clId="{31A66B9B-A4BA-A846-B6C8-9E5957F70A19}" dt="2023-06-05T06:43:29.652" v="12" actId="478"/>
          <ac:spMkLst>
            <pc:docMk/>
            <pc:sldMk cId="752693718" sldId="256"/>
            <ac:spMk id="5" creationId="{84DFEACD-BA69-2CC2-E7E9-82337F3A1AD4}"/>
          </ac:spMkLst>
        </pc:spChg>
      </pc:sldChg>
      <pc:sldChg chg="addSp delSp modSp mod">
        <pc:chgData name="藤井 匡" userId="d0175c71-90dd-4236-b482-6b7f6a599ccb" providerId="ADAL" clId="{31A66B9B-A4BA-A846-B6C8-9E5957F70A19}" dt="2023-06-05T06:44:03.928" v="28" actId="20577"/>
        <pc:sldMkLst>
          <pc:docMk/>
          <pc:sldMk cId="1660982188" sldId="257"/>
        </pc:sldMkLst>
        <pc:spChg chg="add mod">
          <ac:chgData name="藤井 匡" userId="d0175c71-90dd-4236-b482-6b7f6a599ccb" providerId="ADAL" clId="{31A66B9B-A4BA-A846-B6C8-9E5957F70A19}" dt="2023-06-05T06:44:03.928" v="28" actId="20577"/>
          <ac:spMkLst>
            <pc:docMk/>
            <pc:sldMk cId="1660982188" sldId="257"/>
            <ac:spMk id="2" creationId="{97B91C31-6228-8A5A-E404-14CDDEE234DA}"/>
          </ac:spMkLst>
        </pc:spChg>
        <pc:spChg chg="del mod">
          <ac:chgData name="藤井 匡" userId="d0175c71-90dd-4236-b482-6b7f6a599ccb" providerId="ADAL" clId="{31A66B9B-A4BA-A846-B6C8-9E5957F70A19}" dt="2023-06-05T06:43:34.935" v="14" actId="478"/>
          <ac:spMkLst>
            <pc:docMk/>
            <pc:sldMk cId="1660982188" sldId="257"/>
            <ac:spMk id="6" creationId="{8C147BF6-5C38-6A3B-D064-6B00AD12B7B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778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477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325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53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265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624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0119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497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350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309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9634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E0C5A-BDD9-D042-93C1-8222C8AA071A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92173-56E7-3A40-9EA2-E240DC5A94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674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FB9DE92-8402-BCD3-49A7-F9A096B052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9950" y="952500"/>
            <a:ext cx="5613400" cy="76581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10E4F6F-6947-6067-7217-472CB8642067}"/>
              </a:ext>
            </a:extLst>
          </p:cNvPr>
          <p:cNvSpPr txBox="1"/>
          <p:nvPr/>
        </p:nvSpPr>
        <p:spPr>
          <a:xfrm>
            <a:off x="279399" y="9213850"/>
            <a:ext cx="6299201" cy="21929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z="105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ja-JP" sz="105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cleotide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 alignment of GH32 gene from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sequence shown above the alignment indicates the region selected for primer sequence design. CP103178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158, CP040468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CavFT-hAR46, CP103256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592, CP103185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150, CP103162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FG-426, CP072231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CL06T03C10, AP019729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BRC 113806, CP051672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CBBP-1, CP103242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275, CP103079.1:3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FG-244, CP042285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APCS2/PD, CP050956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FDAARGOS_615, CP103286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FG-574, CP054012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FDAARGOS_759, LR215978.1: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C 8503 isolate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82G9, CP107196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olate KR001_HAM_0055, CP103222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157, CP103176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FG-303, CP103148.1: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FG-149, CP103128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162, CP103099.1: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549, CP103122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BFG-308, CP085944.1: 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rain FDAARGOS_1565, CP081908.1: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. </a:t>
            </a:r>
            <a:r>
              <a:rPr lang="en-US" altLang="ja-JP" sz="105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sonis</a:t>
            </a:r>
            <a:r>
              <a:rPr lang="en-US" altLang="ja-JP" sz="105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 BFG-238. </a:t>
            </a:r>
            <a:endParaRPr lang="ja-JP" altLang="ja-JP" sz="105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2693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4</TotalTime>
  <Words>239</Words>
  <Application>Microsoft Macintosh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井 匡</dc:creator>
  <cp:lastModifiedBy>藤井 匡</cp:lastModifiedBy>
  <cp:revision>1</cp:revision>
  <dcterms:created xsi:type="dcterms:W3CDTF">2023-05-14T00:44:08Z</dcterms:created>
  <dcterms:modified xsi:type="dcterms:W3CDTF">2023-06-29T23:09:29Z</dcterms:modified>
</cp:coreProperties>
</file>